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70"/>
  </p:normalViewPr>
  <p:slideViewPr>
    <p:cSldViewPr snapToGrid="0" snapToObjects="1">
      <p:cViewPr varScale="1">
        <p:scale>
          <a:sx n="74" d="100"/>
          <a:sy n="74" d="100"/>
        </p:scale>
        <p:origin x="126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615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242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261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169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641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9564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4138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8540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984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463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70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7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テキスト ボックス 100"/>
          <p:cNvSpPr txBox="1"/>
          <p:nvPr/>
        </p:nvSpPr>
        <p:spPr>
          <a:xfrm>
            <a:off x="0" y="19617"/>
            <a:ext cx="38731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Additional </a:t>
            </a:r>
            <a:r>
              <a:rPr lang="en-US" altLang="ja-JP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Data </a:t>
            </a:r>
            <a:r>
              <a:rPr lang="en-US" altLang="ja-JP" sz="1600" dirty="0" err="1" smtClean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1</a:t>
            </a:r>
            <a:r>
              <a:rPr lang="en-US" altLang="ja-JP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. Primer set used for PCR</a:t>
            </a:r>
            <a:endParaRPr kumimoji="1" lang="ja-JP" altLang="en-US" sz="1600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1946487"/>
              </p:ext>
            </p:extLst>
          </p:nvPr>
        </p:nvGraphicFramePr>
        <p:xfrm>
          <a:off x="304799" y="477091"/>
          <a:ext cx="8322366" cy="5989626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670153">
                  <a:extLst>
                    <a:ext uri="{9D8B030D-6E8A-4147-A177-3AD203B41FA5}">
                      <a16:colId xmlns:a16="http://schemas.microsoft.com/office/drawing/2014/main" xmlns="" val="492023719"/>
                    </a:ext>
                  </a:extLst>
                </a:gridCol>
                <a:gridCol w="342868">
                  <a:extLst>
                    <a:ext uri="{9D8B030D-6E8A-4147-A177-3AD203B41FA5}">
                      <a16:colId xmlns:a16="http://schemas.microsoft.com/office/drawing/2014/main" xmlns="" val="2315323413"/>
                    </a:ext>
                  </a:extLst>
                </a:gridCol>
                <a:gridCol w="483134">
                  <a:extLst>
                    <a:ext uri="{9D8B030D-6E8A-4147-A177-3AD203B41FA5}">
                      <a16:colId xmlns:a16="http://schemas.microsoft.com/office/drawing/2014/main" xmlns="" val="867401143"/>
                    </a:ext>
                  </a:extLst>
                </a:gridCol>
                <a:gridCol w="2680613">
                  <a:extLst>
                    <a:ext uri="{9D8B030D-6E8A-4147-A177-3AD203B41FA5}">
                      <a16:colId xmlns:a16="http://schemas.microsoft.com/office/drawing/2014/main" xmlns="" val="3846821934"/>
                    </a:ext>
                  </a:extLst>
                </a:gridCol>
                <a:gridCol w="670153">
                  <a:extLst>
                    <a:ext uri="{9D8B030D-6E8A-4147-A177-3AD203B41FA5}">
                      <a16:colId xmlns:a16="http://schemas.microsoft.com/office/drawing/2014/main" xmlns="" val="1755658613"/>
                    </a:ext>
                  </a:extLst>
                </a:gridCol>
                <a:gridCol w="327285">
                  <a:extLst>
                    <a:ext uri="{9D8B030D-6E8A-4147-A177-3AD203B41FA5}">
                      <a16:colId xmlns:a16="http://schemas.microsoft.com/office/drawing/2014/main" xmlns="" val="3509258748"/>
                    </a:ext>
                  </a:extLst>
                </a:gridCol>
                <a:gridCol w="467547">
                  <a:extLst>
                    <a:ext uri="{9D8B030D-6E8A-4147-A177-3AD203B41FA5}">
                      <a16:colId xmlns:a16="http://schemas.microsoft.com/office/drawing/2014/main" xmlns="" val="2289571661"/>
                    </a:ext>
                  </a:extLst>
                </a:gridCol>
                <a:gridCol w="2680613">
                  <a:extLst>
                    <a:ext uri="{9D8B030D-6E8A-4147-A177-3AD203B41FA5}">
                      <a16:colId xmlns:a16="http://schemas.microsoft.com/office/drawing/2014/main" xmlns="" val="290030002"/>
                    </a:ext>
                  </a:extLst>
                </a:gridCol>
              </a:tblGrid>
              <a:tr h="3456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b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b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00859128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H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ACTGACTTGGGACCCTCCTC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XFP2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TGTTCTTTGTGTATCTG</a:t>
                      </a:r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099016629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AGGTAGCGGGTGTCT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TGGGACTACAAGCAA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539391721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GTACCAGGGAGTTGCAT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GCAGGAGAATCGTT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3537860537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CACCTGCTCCTTTACG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GCCATAAGGAGGTATT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4037953342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HR2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TTCTTTCCCTGCTTTC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AGAAAAAAGCCTTTGA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3056052921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AGCAGGGCTGGAACAGA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CTGCTACATGTGAGA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460737826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AGCTCTGACCCCTCTC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TCACTTGGTAAATGC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540528159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GAGTTTGGAGGGCTG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GTGCCTCTGAATCTG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2845626826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GACGGAGTCTTGCTC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GCCTCAATCTCATTG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327235795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GGCAGAGCCAGTAGATA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CACATAACCACTACT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234505137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TTGCTTTATGCCCCT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CTGTAGGAATTTGGA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3408789919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AATCCTGTAGGTCCAGA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GACAGCTCTCTTGGTA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958595033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GCATTTGGGACATTGC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TACTGTCACTTCT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4276695998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ACAAGAGGGTCCCTGGAT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CTTGGATGCTCAAAG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4040862166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L3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CCTCTGGGAGAAGTA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CTCGCTAAAAGTTAG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536851478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CAGGAGAATTGCTTGAA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CTTCAGGATAATGTTG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1170134992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ACCCAAACCAGAGTGCT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TTTGGCTGACTCATAC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4130761794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CCTGAGTGACAGAGCAA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TGGGATCTGTGATTCA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2055318273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GACAAGTATCCCCTGGA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GGAGTTCCTCTTGCTA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460619209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TCGTCTCTCCAGCCACT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AAGGGTCATTCATGT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2336639013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AAACTGACACCATC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CCTCATCCAAGTTAC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426574838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ACTTACCCTTCCCTGT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TGAGGCACTAAACTG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2450186381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CTTTTGCTGTCTGAT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812206576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GGATTGCACCACTACT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894816615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TCTGTGCTCTTCCAA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1743520987"/>
                  </a:ext>
                </a:extLst>
              </a:tr>
              <a:tr h="21606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CAGCCCACTATACACG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06" marR="6306" marT="6306" marB="0" anchor="ctr"/>
                </a:tc>
                <a:extLst>
                  <a:ext uri="{0D108BD9-81ED-4DB2-BD59-A6C34878D82A}">
                    <a16:rowId xmlns:a16="http://schemas.microsoft.com/office/drawing/2014/main" xmlns="" val="29491189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0055391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281</Words>
  <Application>Microsoft Office PowerPoint</Application>
  <PresentationFormat>On-screen Show (4:3)</PresentationFormat>
  <Paragraphs>1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ＭＳ Ｐゴシック</vt:lpstr>
      <vt:lpstr>游ゴシック</vt:lpstr>
      <vt:lpstr>Arial</vt:lpstr>
      <vt:lpstr>Calibri</vt:lpstr>
      <vt:lpstr>Calibri Light</vt:lpstr>
      <vt:lpstr>Times New Roman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野健太郎</dc:creator>
  <cp:lastModifiedBy>Janani G.</cp:lastModifiedBy>
  <cp:revision>14</cp:revision>
  <cp:lastPrinted>2020-06-08T06:54:00Z</cp:lastPrinted>
  <dcterms:created xsi:type="dcterms:W3CDTF">2016-05-04T21:35:16Z</dcterms:created>
  <dcterms:modified xsi:type="dcterms:W3CDTF">2020-10-20T05:20:10Z</dcterms:modified>
</cp:coreProperties>
</file>